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78" t="10382" r="5581" b="8760"/>
          <a:stretch/>
        </p:blipFill>
        <p:spPr>
          <a:xfrm>
            <a:off x="3565452" y="1519148"/>
            <a:ext cx="2544726" cy="231081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0" t="9638" r="5404" b="9009"/>
          <a:stretch/>
        </p:blipFill>
        <p:spPr>
          <a:xfrm>
            <a:off x="418214" y="1497882"/>
            <a:ext cx="2530549" cy="232498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251484" y="1319644"/>
            <a:ext cx="1077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ensit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423531" y="1320888"/>
            <a:ext cx="1077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ensit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84285" y="3810425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b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WT1)/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b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WT2)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098920" y="3830479"/>
            <a:ext cx="1630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b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O1)/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b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O2)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0800000">
            <a:off x="94248" y="2319358"/>
            <a:ext cx="338554" cy="55399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0800000">
            <a:off x="3269079" y="2326446"/>
            <a:ext cx="338554" cy="55399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880944" y="2042704"/>
            <a:ext cx="9685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dian=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D=0.4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042407" y="2042704"/>
            <a:ext cx="9252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dian=0.09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D=0.4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38796" y="4329417"/>
            <a:ext cx="5526834" cy="6639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b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gene body regions: </a:t>
            </a:r>
            <a:r>
              <a:rPr lang="en-US" sz="10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bd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read density in gene body regions; WT1: wildtype liver replicate 1; WT2; wildtype liver replicate 2; KO1: </a:t>
            </a:r>
            <a:r>
              <a:rPr lang="en-US" sz="10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dac3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deleted liver replicate 1; KO2: </a:t>
            </a:r>
            <a:r>
              <a:rPr lang="en-US" sz="1000" i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dac3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deleted liver replicate 2.</a:t>
            </a:r>
            <a:endParaRPr lang="en-US" sz="10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32621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63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8</cp:revision>
  <cp:lastPrinted>2016-09-27T21:35:30Z</cp:lastPrinted>
  <dcterms:created xsi:type="dcterms:W3CDTF">2016-09-06T21:27:57Z</dcterms:created>
  <dcterms:modified xsi:type="dcterms:W3CDTF">2018-07-10T18:24:10Z</dcterms:modified>
</cp:coreProperties>
</file>